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A1D7F-D58F-4A05-BBAF-1DB5C29466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5D8BC-8B40-4C78-B727-8951901C5B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734AF9-4994-406E-AA59-5C25A9E27E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89B0E-B392-4624-8100-62945C83EA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E6C42-2C35-4B92-B339-B06BA51F5A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BADA0-9C91-4081-9656-1CF2E9D5FF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DB6EB-0C1E-43C0-B713-60E41D8745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64EAD-F43F-4776-96A5-499C359A59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86EE4C-0D50-4335-8AE3-A1D01954ED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8DDF0C-F852-45E4-90ED-CC9EB1DCA8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28EB9-4A11-490B-B064-2A3EE52E8A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E4C02-FC47-4696-A4B0-24556577FA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B56285-E204-465B-AE31-B69DBC92643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7285" r="0" b="9206"/>
          <a:stretch/>
        </p:blipFill>
        <p:spPr>
          <a:xfrm>
            <a:off x="446040" y="2597040"/>
            <a:ext cx="1542960" cy="11829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10891" r="0" b="5605"/>
          <a:stretch/>
        </p:blipFill>
        <p:spPr>
          <a:xfrm>
            <a:off x="446040" y="3821040"/>
            <a:ext cx="1542960" cy="11826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rcRect l="0" t="10891" r="0" b="5605"/>
          <a:stretch/>
        </p:blipFill>
        <p:spPr>
          <a:xfrm>
            <a:off x="446040" y="5045040"/>
            <a:ext cx="1542960" cy="118260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rcRect l="0" t="10882" r="0" b="5677"/>
          <a:stretch/>
        </p:blipFill>
        <p:spPr>
          <a:xfrm>
            <a:off x="446040" y="6269040"/>
            <a:ext cx="1542960" cy="118260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rcRect l="0" t="10891" r="0" b="5605"/>
          <a:stretch/>
        </p:blipFill>
        <p:spPr>
          <a:xfrm>
            <a:off x="446040" y="1346040"/>
            <a:ext cx="1542960" cy="118296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6"/>
          <a:srcRect l="0" t="14657" r="0" b="1371"/>
          <a:stretch/>
        </p:blipFill>
        <p:spPr>
          <a:xfrm>
            <a:off x="2031840" y="1346040"/>
            <a:ext cx="1532160" cy="118116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7">
            <a:lum bright="-12000"/>
          </a:blip>
          <a:srcRect l="0" t="14493" r="0" b="1921"/>
          <a:stretch/>
        </p:blipFill>
        <p:spPr>
          <a:xfrm>
            <a:off x="2031840" y="2595600"/>
            <a:ext cx="1541520" cy="118440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8">
            <a:lum bright="-6000"/>
          </a:blip>
          <a:srcRect l="0" t="14483" r="0" b="1999"/>
          <a:stretch/>
        </p:blipFill>
        <p:spPr>
          <a:xfrm>
            <a:off x="2031840" y="3819600"/>
            <a:ext cx="1541520" cy="118404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9"/>
          <a:srcRect l="0" t="14502" r="0" b="1844"/>
          <a:stretch/>
        </p:blipFill>
        <p:spPr>
          <a:xfrm>
            <a:off x="2031840" y="5043600"/>
            <a:ext cx="1541520" cy="118404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10"/>
          <a:srcRect l="0" t="14493" r="0" b="1921"/>
          <a:stretch/>
        </p:blipFill>
        <p:spPr>
          <a:xfrm>
            <a:off x="2031840" y="6267600"/>
            <a:ext cx="1541520" cy="118404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11"/>
          <a:stretch/>
        </p:blipFill>
        <p:spPr>
          <a:xfrm>
            <a:off x="3613320" y="3814920"/>
            <a:ext cx="1544400" cy="118872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12"/>
          <a:stretch/>
        </p:blipFill>
        <p:spPr>
          <a:xfrm>
            <a:off x="3614760" y="2592360"/>
            <a:ext cx="1542960" cy="118764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13"/>
          <a:stretch/>
        </p:blipFill>
        <p:spPr>
          <a:xfrm>
            <a:off x="3614760" y="5040360"/>
            <a:ext cx="1542960" cy="118728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14"/>
          <a:stretch/>
        </p:blipFill>
        <p:spPr>
          <a:xfrm>
            <a:off x="3614760" y="6264360"/>
            <a:ext cx="1542960" cy="118728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15"/>
          <a:stretch/>
        </p:blipFill>
        <p:spPr>
          <a:xfrm>
            <a:off x="3614760" y="1346040"/>
            <a:ext cx="1542960" cy="118908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427320" y="1060560"/>
            <a:ext cx="6180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b-NO" sz="1600" spc="-1" strike="noStrike">
                <a:solidFill>
                  <a:srgbClr val="000000"/>
                </a:solidFill>
                <a:latin typeface="Arial"/>
              </a:rPr>
              <a:t>24h post PDT     24h post PCI      48h post PDT      48h post PC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-2906640" y="4042440"/>
            <a:ext cx="6323760" cy="388800"/>
          </a:xfrm>
          <a:prstGeom prst="rect">
            <a:avLst/>
          </a:prstGeom>
          <a:solidFill>
            <a:srgbClr val="9696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b-NO" sz="1700" spc="-1" strike="noStrike">
                <a:solidFill>
                  <a:srgbClr val="66ff33"/>
                </a:solidFill>
                <a:latin typeface="Arial"/>
              </a:rPr>
              <a:t>G</a:t>
            </a:r>
            <a:r>
              <a:rPr b="1" lang="nb-NO" sz="17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1" lang="nb-NO" sz="1700" spc="-1" strike="noStrike">
                <a:solidFill>
                  <a:srgbClr val="0000ff"/>
                </a:solidFill>
                <a:latin typeface="Arial"/>
              </a:rPr>
              <a:t>H</a:t>
            </a:r>
            <a:r>
              <a:rPr b="1" lang="nb-NO" sz="17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1" lang="nb-NO" sz="1700" spc="-1" strike="noStrike">
                <a:solidFill>
                  <a:srgbClr val="ff0000"/>
                </a:solidFill>
                <a:latin typeface="Arial"/>
              </a:rPr>
              <a:t>A</a:t>
            </a:r>
            <a:r>
              <a:rPr b="1" lang="nb-NO" sz="17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nb-NO" sz="1700" spc="-1" strike="noStrike">
                <a:solidFill>
                  <a:srgbClr val="0000ff"/>
                </a:solidFill>
                <a:latin typeface="Arial"/>
              </a:rPr>
              <a:t>Hoechst 33342</a:t>
            </a:r>
            <a:r>
              <a:rPr b="1" lang="nb-NO" sz="17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nb-NO" sz="1700" spc="-1" strike="noStrike">
                <a:solidFill>
                  <a:srgbClr val="ff0000"/>
                </a:solidFill>
                <a:latin typeface="Arial"/>
              </a:rPr>
              <a:t>AlPcS</a:t>
            </a:r>
            <a:r>
              <a:rPr b="1" lang="nb-NO" sz="1700" spc="-1" strike="noStrike" baseline="-25000">
                <a:solidFill>
                  <a:srgbClr val="ff0000"/>
                </a:solidFill>
                <a:latin typeface="Arial"/>
              </a:rPr>
              <a:t>2a</a:t>
            </a:r>
            <a:r>
              <a:rPr b="1" lang="nb-NO" sz="1700" spc="-1" strike="noStrike">
                <a:solidFill>
                  <a:srgbClr val="000000"/>
                </a:solidFill>
                <a:latin typeface="Arial"/>
              </a:rPr>
              <a:t>         </a:t>
            </a:r>
            <a:r>
              <a:rPr b="1" lang="nb-NO" sz="1700" spc="-1" strike="noStrike">
                <a:solidFill>
                  <a:srgbClr val="66ff33"/>
                </a:solidFill>
                <a:latin typeface="Arial"/>
              </a:rPr>
              <a:t>GFP     </a:t>
            </a:r>
            <a:r>
              <a:rPr b="1" lang="nb-NO" sz="1700" spc="-1" strike="noStrike">
                <a:solidFill>
                  <a:srgbClr val="000000"/>
                </a:solidFill>
                <a:latin typeface="Arial"/>
              </a:rPr>
              <a:t>Phase contrast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76280" y="7667640"/>
            <a:ext cx="61927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16"/>
          <a:stretch/>
        </p:blipFill>
        <p:spPr>
          <a:xfrm>
            <a:off x="5199120" y="1349280"/>
            <a:ext cx="1544760" cy="118764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17"/>
          <a:stretch/>
        </p:blipFill>
        <p:spPr>
          <a:xfrm>
            <a:off x="5197320" y="2592360"/>
            <a:ext cx="1544760" cy="118764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18"/>
          <a:stretch/>
        </p:blipFill>
        <p:spPr>
          <a:xfrm>
            <a:off x="5197320" y="3816360"/>
            <a:ext cx="1544760" cy="118728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19"/>
          <a:stretch/>
        </p:blipFill>
        <p:spPr>
          <a:xfrm>
            <a:off x="5197320" y="5040360"/>
            <a:ext cx="1544760" cy="118728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20"/>
          <a:stretch/>
        </p:blipFill>
        <p:spPr>
          <a:xfrm>
            <a:off x="5197320" y="6264360"/>
            <a:ext cx="1544760" cy="118728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691920" y="250200"/>
            <a:ext cx="262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3. Selbo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19T11:56:34Z</dcterms:created>
  <dc:creator>Pål Kristian Selbo</dc:creator>
  <dc:description/>
  <dc:language>en-US</dc:language>
  <cp:lastModifiedBy>Pål Kristian Selbo</cp:lastModifiedBy>
  <dcterms:modified xsi:type="dcterms:W3CDTF">2009-06-02T07:47:40Z</dcterms:modified>
  <cp:revision>6</cp:revision>
  <dc:subject/>
  <dc:title>Slide 1</dc:title>
</cp:coreProperties>
</file>